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1836F-4089-43FE-9B76-51AFCEF4439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A76561-D9CC-412A-8CE1-EFDC1F7160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565F90-029F-4785-8495-EBD1A35055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A2E44-2716-4C6D-A217-539222D2CC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4A7020-A57E-45B5-A1CD-F983FCE649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46CA3-EDCA-4421-81AB-97EB12BF60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6FD3FD-01B0-4A3E-9C97-65C21A7BC3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6E53E-627C-4030-8241-7E13F47989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5834E-F414-444B-9D03-91BC7024658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93535-35ED-45D9-8210-946C1BE27A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DA564-40E6-43CB-9C96-71708CC829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C56C8-D968-411E-BAD2-51CE47F16E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F20694-F5B3-45DB-BF55-60A597A4222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"/>
          <p:cNvGrpSpPr/>
          <p:nvPr/>
        </p:nvGrpSpPr>
        <p:grpSpPr>
          <a:xfrm>
            <a:off x="2438280" y="1746360"/>
            <a:ext cx="4046760" cy="2785320"/>
            <a:chOff x="2438280" y="1746360"/>
            <a:chExt cx="4046760" cy="2785320"/>
          </a:xfrm>
        </p:grpSpPr>
        <p:grpSp>
          <p:nvGrpSpPr>
            <p:cNvPr id="42" name="Group 104"/>
            <p:cNvGrpSpPr/>
            <p:nvPr/>
          </p:nvGrpSpPr>
          <p:grpSpPr>
            <a:xfrm>
              <a:off x="2438280" y="2777760"/>
              <a:ext cx="2851200" cy="1753920"/>
              <a:chOff x="2438280" y="2777760"/>
              <a:chExt cx="2851200" cy="1753920"/>
            </a:xfrm>
          </p:grpSpPr>
          <p:sp>
            <p:nvSpPr>
              <p:cNvPr id="43" name="Rectangle 168"/>
              <p:cNvSpPr/>
              <p:nvPr/>
            </p:nvSpPr>
            <p:spPr>
              <a:xfrm>
                <a:off x="4279680" y="4287960"/>
                <a:ext cx="100980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EtBr (</a:t>
                </a:r>
                <a:r>
                  <a:rPr b="0" lang="el-GR" sz="16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μ</a:t>
                </a: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g/ml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4" name="Rectangle 3"/>
              <p:cNvSpPr/>
              <p:nvPr/>
            </p:nvSpPr>
            <p:spPr>
              <a:xfrm rot="16200000">
                <a:off x="2197080" y="3018600"/>
                <a:ext cx="81936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Calibri"/>
                    <a:ea typeface="新細明體"/>
                  </a:rPr>
                  <a:t>GFP (%)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45" name="Picture 78" descr=""/>
            <p:cNvPicPr/>
            <p:nvPr/>
          </p:nvPicPr>
          <p:blipFill>
            <a:blip r:embed="rId1"/>
            <a:stretch/>
          </p:blipFill>
          <p:spPr>
            <a:xfrm>
              <a:off x="2778840" y="1746360"/>
              <a:ext cx="3706200" cy="27716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6" name="Rectangle 313"/>
          <p:cNvSpPr/>
          <p:nvPr/>
        </p:nvSpPr>
        <p:spPr>
          <a:xfrm>
            <a:off x="425520" y="5102280"/>
            <a:ext cx="839304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Additional File. 1 Effects of EtBr on GFP expression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新細明體"/>
              </a:rPr>
              <a:t>293T cells were transfected with GFP expressing plasmid under the control of a CMV promoter. The transfected cells were then washed and replenished with media containing various concentrations of EtBr at six hours post-transfection. The GFP signal was measured with a luminometer (Victor3, PerkinElmer) at 22 hours post-transfection. The GFP signal of the mock-treated cells was taken as 100% polymerase activity. Data ± SE were obtained from the triplicate experiments.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1T04:06:14Z</dcterms:created>
  <dc:creator>llmpoon</dc:creator>
  <dc:description/>
  <dc:language>en-US</dc:language>
  <cp:lastModifiedBy>llmpoon</cp:lastModifiedBy>
  <dcterms:modified xsi:type="dcterms:W3CDTF">2011-02-01T04:06:40Z</dcterms:modified>
  <cp:revision>1</cp:revision>
  <dc:subject/>
  <dc:title>Slide 1</dc:title>
</cp:coreProperties>
</file>